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8" r:id="rId3"/>
    <p:sldId id="260" r:id="rId4"/>
    <p:sldId id="259" r:id="rId5"/>
    <p:sldId id="261" r:id="rId6"/>
  </p:sldIdLst>
  <p:sldSz cx="12192000" cy="6858000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BCA205C5-AFF6-4012-A7EF-CDC62B150E55}" v="21" dt="2026-01-14T00:54:17.784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6996" autoAdjust="0"/>
    <p:restoredTop sz="94660"/>
  </p:normalViewPr>
  <p:slideViewPr>
    <p:cSldViewPr snapToGrid="0">
      <p:cViewPr varScale="1">
        <p:scale>
          <a:sx n="110" d="100"/>
          <a:sy n="110" d="100"/>
        </p:scale>
        <p:origin x="516" y="11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12" Type="http://schemas.microsoft.com/office/2015/10/relationships/revisionInfo" Target="revisionInfo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microsoft.com/office/2016/11/relationships/changesInfo" Target="changesInfos/changesInfo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juyoung jung" userId="2cd33e9aba789339" providerId="LiveId" clId="{AA236221-2BE9-4F5F-A09F-FD46EB557B01}"/>
    <pc:docChg chg="undo custSel addSld delSld modSld sldOrd">
      <pc:chgData name="juyoung jung" userId="2cd33e9aba789339" providerId="LiveId" clId="{AA236221-2BE9-4F5F-A09F-FD46EB557B01}" dt="2026-01-14T00:55:14.842" v="382" actId="20577"/>
      <pc:docMkLst>
        <pc:docMk/>
      </pc:docMkLst>
      <pc:sldChg chg="addSp delSp modSp mod">
        <pc:chgData name="juyoung jung" userId="2cd33e9aba789339" providerId="LiveId" clId="{AA236221-2BE9-4F5F-A09F-FD46EB557B01}" dt="2026-01-14T00:51:46.265" v="318" actId="20577"/>
        <pc:sldMkLst>
          <pc:docMk/>
          <pc:sldMk cId="3586287062" sldId="257"/>
        </pc:sldMkLst>
        <pc:spChg chg="add del mod">
          <ac:chgData name="juyoung jung" userId="2cd33e9aba789339" providerId="LiveId" clId="{AA236221-2BE9-4F5F-A09F-FD46EB557B01}" dt="2026-01-14T00:41:23.958" v="168"/>
          <ac:spMkLst>
            <pc:docMk/>
            <pc:sldMk cId="3586287062" sldId="257"/>
            <ac:spMk id="3" creationId="{DD3E39D1-4C18-600C-EB11-5EE96F531BC7}"/>
          </ac:spMkLst>
        </pc:spChg>
        <pc:spChg chg="mod">
          <ac:chgData name="juyoung jung" userId="2cd33e9aba789339" providerId="LiveId" clId="{AA236221-2BE9-4F5F-A09F-FD46EB557B01}" dt="2026-01-14T00:51:46.265" v="318" actId="20577"/>
          <ac:spMkLst>
            <pc:docMk/>
            <pc:sldMk cId="3586287062" sldId="257"/>
            <ac:spMk id="5" creationId="{00000000-0000-0000-0000-000000000000}"/>
          </ac:spMkLst>
        </pc:spChg>
        <pc:picChg chg="del mod">
          <ac:chgData name="juyoung jung" userId="2cd33e9aba789339" providerId="LiveId" clId="{AA236221-2BE9-4F5F-A09F-FD46EB557B01}" dt="2026-01-14T00:41:14.866" v="167" actId="21"/>
          <ac:picMkLst>
            <pc:docMk/>
            <pc:sldMk cId="3586287062" sldId="257"/>
            <ac:picMk id="4" creationId="{00000000-0000-0000-0000-000000000000}"/>
          </ac:picMkLst>
        </pc:picChg>
        <pc:picChg chg="add mod">
          <ac:chgData name="juyoung jung" userId="2cd33e9aba789339" providerId="LiveId" clId="{AA236221-2BE9-4F5F-A09F-FD46EB557B01}" dt="2026-01-14T00:41:44.553" v="177" actId="14100"/>
          <ac:picMkLst>
            <pc:docMk/>
            <pc:sldMk cId="3586287062" sldId="257"/>
            <ac:picMk id="8" creationId="{3768716D-B2F1-0E9C-21DA-C561F1802626}"/>
          </ac:picMkLst>
        </pc:picChg>
      </pc:sldChg>
      <pc:sldChg chg="del">
        <pc:chgData name="juyoung jung" userId="2cd33e9aba789339" providerId="LiveId" clId="{AA236221-2BE9-4F5F-A09F-FD46EB557B01}" dt="2026-01-14T00:42:25.168" v="249" actId="2696"/>
        <pc:sldMkLst>
          <pc:docMk/>
          <pc:sldMk cId="2730808792" sldId="258"/>
        </pc:sldMkLst>
      </pc:sldChg>
      <pc:sldChg chg="modSp add mod">
        <pc:chgData name="juyoung jung" userId="2cd33e9aba789339" providerId="LiveId" clId="{AA236221-2BE9-4F5F-A09F-FD46EB557B01}" dt="2026-01-14T00:51:49.834" v="320" actId="20577"/>
        <pc:sldMkLst>
          <pc:docMk/>
          <pc:sldMk cId="3761748432" sldId="258"/>
        </pc:sldMkLst>
        <pc:spChg chg="mod">
          <ac:chgData name="juyoung jung" userId="2cd33e9aba789339" providerId="LiveId" clId="{AA236221-2BE9-4F5F-A09F-FD46EB557B01}" dt="2026-01-14T00:51:49.834" v="320" actId="20577"/>
          <ac:spMkLst>
            <pc:docMk/>
            <pc:sldMk cId="3761748432" sldId="258"/>
            <ac:spMk id="5" creationId="{DD6B9412-378D-BA20-9915-1F7FDB2B396D}"/>
          </ac:spMkLst>
        </pc:spChg>
        <pc:spChg chg="mod">
          <ac:chgData name="juyoung jung" userId="2cd33e9aba789339" providerId="LiveId" clId="{AA236221-2BE9-4F5F-A09F-FD46EB557B01}" dt="2026-01-14T00:42:38.944" v="252" actId="20577"/>
          <ac:spMkLst>
            <pc:docMk/>
            <pc:sldMk cId="3761748432" sldId="258"/>
            <ac:spMk id="6" creationId="{5960B0CE-E762-07DA-FB0D-45AE865F6E01}"/>
          </ac:spMkLst>
        </pc:spChg>
        <pc:picChg chg="mod">
          <ac:chgData name="juyoung jung" userId="2cd33e9aba789339" providerId="LiveId" clId="{AA236221-2BE9-4F5F-A09F-FD46EB557B01}" dt="2026-01-14T00:42:54.804" v="258" actId="14826"/>
          <ac:picMkLst>
            <pc:docMk/>
            <pc:sldMk cId="3761748432" sldId="258"/>
            <ac:picMk id="8" creationId="{3541C844-66CB-C576-1C2F-0BE227F8B28D}"/>
          </ac:picMkLst>
        </pc:picChg>
      </pc:sldChg>
      <pc:sldChg chg="del">
        <pc:chgData name="juyoung jung" userId="2cd33e9aba789339" providerId="LiveId" clId="{AA236221-2BE9-4F5F-A09F-FD46EB557B01}" dt="2026-01-14T00:42:25.168" v="249" actId="2696"/>
        <pc:sldMkLst>
          <pc:docMk/>
          <pc:sldMk cId="649458596" sldId="259"/>
        </pc:sldMkLst>
      </pc:sldChg>
      <pc:sldChg chg="modSp add mod">
        <pc:chgData name="juyoung jung" userId="2cd33e9aba789339" providerId="LiveId" clId="{AA236221-2BE9-4F5F-A09F-FD46EB557B01}" dt="2026-01-14T00:51:58.757" v="325" actId="20577"/>
        <pc:sldMkLst>
          <pc:docMk/>
          <pc:sldMk cId="3845637068" sldId="259"/>
        </pc:sldMkLst>
        <pc:spChg chg="mod">
          <ac:chgData name="juyoung jung" userId="2cd33e9aba789339" providerId="LiveId" clId="{AA236221-2BE9-4F5F-A09F-FD46EB557B01}" dt="2026-01-14T00:51:58.757" v="325" actId="20577"/>
          <ac:spMkLst>
            <pc:docMk/>
            <pc:sldMk cId="3845637068" sldId="259"/>
            <ac:spMk id="5" creationId="{C8210C0E-6DD6-F569-8F14-E0CEDAFB67CC}"/>
          </ac:spMkLst>
        </pc:spChg>
        <pc:spChg chg="mod">
          <ac:chgData name="juyoung jung" userId="2cd33e9aba789339" providerId="LiveId" clId="{AA236221-2BE9-4F5F-A09F-FD46EB557B01}" dt="2026-01-14T00:44:54.142" v="292" actId="20577"/>
          <ac:spMkLst>
            <pc:docMk/>
            <pc:sldMk cId="3845637068" sldId="259"/>
            <ac:spMk id="6" creationId="{FDB595E4-DC5B-D2DA-8FBE-31ABC283ECD7}"/>
          </ac:spMkLst>
        </pc:spChg>
      </pc:sldChg>
      <pc:sldChg chg="new del">
        <pc:chgData name="juyoung jung" userId="2cd33e9aba789339" providerId="LiveId" clId="{AA236221-2BE9-4F5F-A09F-FD46EB557B01}" dt="2026-01-14T00:43:42.889" v="269" actId="680"/>
        <pc:sldMkLst>
          <pc:docMk/>
          <pc:sldMk cId="758507618" sldId="260"/>
        </pc:sldMkLst>
      </pc:sldChg>
      <pc:sldChg chg="del">
        <pc:chgData name="juyoung jung" userId="2cd33e9aba789339" providerId="LiveId" clId="{AA236221-2BE9-4F5F-A09F-FD46EB557B01}" dt="2026-01-14T00:42:25.168" v="249" actId="2696"/>
        <pc:sldMkLst>
          <pc:docMk/>
          <pc:sldMk cId="777955275" sldId="260"/>
        </pc:sldMkLst>
      </pc:sldChg>
      <pc:sldChg chg="modSp add mod ord">
        <pc:chgData name="juyoung jung" userId="2cd33e9aba789339" providerId="LiveId" clId="{AA236221-2BE9-4F5F-A09F-FD46EB557B01}" dt="2026-01-14T00:51:55.547" v="323" actId="14100"/>
        <pc:sldMkLst>
          <pc:docMk/>
          <pc:sldMk cId="2931836604" sldId="260"/>
        </pc:sldMkLst>
        <pc:spChg chg="mod">
          <ac:chgData name="juyoung jung" userId="2cd33e9aba789339" providerId="LiveId" clId="{AA236221-2BE9-4F5F-A09F-FD46EB557B01}" dt="2026-01-14T00:51:55.547" v="323" actId="14100"/>
          <ac:spMkLst>
            <pc:docMk/>
            <pc:sldMk cId="2931836604" sldId="260"/>
            <ac:spMk id="5" creationId="{3780BE0B-03D2-241F-91E8-4B15C600944C}"/>
          </ac:spMkLst>
        </pc:spChg>
        <pc:spChg chg="mod">
          <ac:chgData name="juyoung jung" userId="2cd33e9aba789339" providerId="LiveId" clId="{AA236221-2BE9-4F5F-A09F-FD46EB557B01}" dt="2026-01-14T00:44:33.846" v="281" actId="20577"/>
          <ac:spMkLst>
            <pc:docMk/>
            <pc:sldMk cId="2931836604" sldId="260"/>
            <ac:spMk id="6" creationId="{A6EDB326-B2E4-CDDC-F286-1F28F13410A6}"/>
          </ac:spMkLst>
        </pc:spChg>
      </pc:sldChg>
      <pc:sldChg chg="modSp add mod">
        <pc:chgData name="juyoung jung" userId="2cd33e9aba789339" providerId="LiveId" clId="{AA236221-2BE9-4F5F-A09F-FD46EB557B01}" dt="2026-01-14T00:52:02.726" v="327" actId="20577"/>
        <pc:sldMkLst>
          <pc:docMk/>
          <pc:sldMk cId="3292900752" sldId="261"/>
        </pc:sldMkLst>
        <pc:spChg chg="mod">
          <ac:chgData name="juyoung jung" userId="2cd33e9aba789339" providerId="LiveId" clId="{AA236221-2BE9-4F5F-A09F-FD46EB557B01}" dt="2026-01-14T00:52:02.726" v="327" actId="20577"/>
          <ac:spMkLst>
            <pc:docMk/>
            <pc:sldMk cId="3292900752" sldId="261"/>
            <ac:spMk id="5" creationId="{C4A3BC84-AAE2-7D27-B1B4-C1255EF3949E}"/>
          </ac:spMkLst>
        </pc:spChg>
        <pc:spChg chg="mod">
          <ac:chgData name="juyoung jung" userId="2cd33e9aba789339" providerId="LiveId" clId="{AA236221-2BE9-4F5F-A09F-FD46EB557B01}" dt="2026-01-14T00:45:22.433" v="298" actId="20577"/>
          <ac:spMkLst>
            <pc:docMk/>
            <pc:sldMk cId="3292900752" sldId="261"/>
            <ac:spMk id="6" creationId="{6A94608A-596A-A969-54C4-8C7BF4423D5F}"/>
          </ac:spMkLst>
        </pc:spChg>
        <pc:picChg chg="mod">
          <ac:chgData name="juyoung jung" userId="2cd33e9aba789339" providerId="LiveId" clId="{AA236221-2BE9-4F5F-A09F-FD46EB557B01}" dt="2026-01-14T00:45:32.997" v="299" actId="14826"/>
          <ac:picMkLst>
            <pc:docMk/>
            <pc:sldMk cId="3292900752" sldId="261"/>
            <ac:picMk id="8" creationId="{0BCA3891-1896-F941-4B62-9A677661E6F0}"/>
          </ac:picMkLst>
        </pc:picChg>
      </pc:sldChg>
      <pc:sldChg chg="modSp add mod">
        <pc:chgData name="juyoung jung" userId="2cd33e9aba789339" providerId="LiveId" clId="{AA236221-2BE9-4F5F-A09F-FD46EB557B01}" dt="2026-01-14T00:52:29.395" v="337" actId="20577"/>
        <pc:sldMkLst>
          <pc:docMk/>
          <pc:sldMk cId="2838625645" sldId="262"/>
        </pc:sldMkLst>
        <pc:spChg chg="mod">
          <ac:chgData name="juyoung jung" userId="2cd33e9aba789339" providerId="LiveId" clId="{AA236221-2BE9-4F5F-A09F-FD46EB557B01}" dt="2026-01-14T00:52:29.395" v="337" actId="20577"/>
          <ac:spMkLst>
            <pc:docMk/>
            <pc:sldMk cId="2838625645" sldId="262"/>
            <ac:spMk id="5" creationId="{70DEA4BF-45AA-F88C-A57C-1A0525E7F50C}"/>
          </ac:spMkLst>
        </pc:spChg>
        <pc:picChg chg="mod">
          <ac:chgData name="juyoung jung" userId="2cd33e9aba789339" providerId="LiveId" clId="{AA236221-2BE9-4F5F-A09F-FD46EB557B01}" dt="2026-01-14T00:50:00.736" v="308" actId="14826"/>
          <ac:picMkLst>
            <pc:docMk/>
            <pc:sldMk cId="2838625645" sldId="262"/>
            <ac:picMk id="8" creationId="{690DED58-EADD-6757-357A-1B6276E5D91F}"/>
          </ac:picMkLst>
        </pc:picChg>
      </pc:sldChg>
      <pc:sldChg chg="modSp add mod">
        <pc:chgData name="juyoung jung" userId="2cd33e9aba789339" providerId="LiveId" clId="{AA236221-2BE9-4F5F-A09F-FD46EB557B01}" dt="2026-01-14T00:52:31.891" v="338" actId="20577"/>
        <pc:sldMkLst>
          <pc:docMk/>
          <pc:sldMk cId="591835417" sldId="263"/>
        </pc:sldMkLst>
        <pc:spChg chg="mod">
          <ac:chgData name="juyoung jung" userId="2cd33e9aba789339" providerId="LiveId" clId="{AA236221-2BE9-4F5F-A09F-FD46EB557B01}" dt="2026-01-14T00:52:31.891" v="338" actId="20577"/>
          <ac:spMkLst>
            <pc:docMk/>
            <pc:sldMk cId="591835417" sldId="263"/>
            <ac:spMk id="5" creationId="{99D2FACF-43E7-D216-C0BE-354E016255E0}"/>
          </ac:spMkLst>
        </pc:spChg>
        <pc:picChg chg="mod">
          <ac:chgData name="juyoung jung" userId="2cd33e9aba789339" providerId="LiveId" clId="{AA236221-2BE9-4F5F-A09F-FD46EB557B01}" dt="2026-01-14T00:50:30.734" v="310" actId="14826"/>
          <ac:picMkLst>
            <pc:docMk/>
            <pc:sldMk cId="591835417" sldId="263"/>
            <ac:picMk id="8" creationId="{7A9D7A01-F48C-0FD2-8BF8-263CD956AB51}"/>
          </ac:picMkLst>
        </pc:picChg>
      </pc:sldChg>
      <pc:sldChg chg="modSp add mod">
        <pc:chgData name="juyoung jung" userId="2cd33e9aba789339" providerId="LiveId" clId="{AA236221-2BE9-4F5F-A09F-FD46EB557B01}" dt="2026-01-14T00:52:34.656" v="339" actId="20577"/>
        <pc:sldMkLst>
          <pc:docMk/>
          <pc:sldMk cId="3759865934" sldId="264"/>
        </pc:sldMkLst>
        <pc:spChg chg="mod">
          <ac:chgData name="juyoung jung" userId="2cd33e9aba789339" providerId="LiveId" clId="{AA236221-2BE9-4F5F-A09F-FD46EB557B01}" dt="2026-01-14T00:52:34.656" v="339" actId="20577"/>
          <ac:spMkLst>
            <pc:docMk/>
            <pc:sldMk cId="3759865934" sldId="264"/>
            <ac:spMk id="5" creationId="{D51026B7-573E-82FD-8415-7348BF55F589}"/>
          </ac:spMkLst>
        </pc:spChg>
        <pc:picChg chg="mod">
          <ac:chgData name="juyoung jung" userId="2cd33e9aba789339" providerId="LiveId" clId="{AA236221-2BE9-4F5F-A09F-FD46EB557B01}" dt="2026-01-14T00:51:01.790" v="311" actId="14826"/>
          <ac:picMkLst>
            <pc:docMk/>
            <pc:sldMk cId="3759865934" sldId="264"/>
            <ac:picMk id="8" creationId="{9882A6D3-4C85-9E0D-F27D-459F1505A6FB}"/>
          </ac:picMkLst>
        </pc:picChg>
      </pc:sldChg>
      <pc:sldChg chg="modSp add mod">
        <pc:chgData name="juyoung jung" userId="2cd33e9aba789339" providerId="LiveId" clId="{AA236221-2BE9-4F5F-A09F-FD46EB557B01}" dt="2026-01-14T00:52:37.188" v="340" actId="20577"/>
        <pc:sldMkLst>
          <pc:docMk/>
          <pc:sldMk cId="2314482421" sldId="265"/>
        </pc:sldMkLst>
        <pc:spChg chg="mod">
          <ac:chgData name="juyoung jung" userId="2cd33e9aba789339" providerId="LiveId" clId="{AA236221-2BE9-4F5F-A09F-FD46EB557B01}" dt="2026-01-14T00:52:37.188" v="340" actId="20577"/>
          <ac:spMkLst>
            <pc:docMk/>
            <pc:sldMk cId="2314482421" sldId="265"/>
            <ac:spMk id="5" creationId="{2E9F19FA-3197-45A9-1D74-E1F5CB633C58}"/>
          </ac:spMkLst>
        </pc:spChg>
        <pc:picChg chg="mod">
          <ac:chgData name="juyoung jung" userId="2cd33e9aba789339" providerId="LiveId" clId="{AA236221-2BE9-4F5F-A09F-FD46EB557B01}" dt="2026-01-14T00:51:08.902" v="312" actId="14826"/>
          <ac:picMkLst>
            <pc:docMk/>
            <pc:sldMk cId="2314482421" sldId="265"/>
            <ac:picMk id="8" creationId="{36F04604-5BB3-50DD-8CC8-E8BBB4E314B0}"/>
          </ac:picMkLst>
        </pc:picChg>
      </pc:sldChg>
      <pc:sldChg chg="modSp add mod">
        <pc:chgData name="juyoung jung" userId="2cd33e9aba789339" providerId="LiveId" clId="{AA236221-2BE9-4F5F-A09F-FD46EB557B01}" dt="2026-01-14T00:52:40.920" v="341" actId="20577"/>
        <pc:sldMkLst>
          <pc:docMk/>
          <pc:sldMk cId="1197021954" sldId="266"/>
        </pc:sldMkLst>
        <pc:spChg chg="mod">
          <ac:chgData name="juyoung jung" userId="2cd33e9aba789339" providerId="LiveId" clId="{AA236221-2BE9-4F5F-A09F-FD46EB557B01}" dt="2026-01-14T00:52:40.920" v="341" actId="20577"/>
          <ac:spMkLst>
            <pc:docMk/>
            <pc:sldMk cId="1197021954" sldId="266"/>
            <ac:spMk id="5" creationId="{8F98FFBA-BD2A-5EB4-1604-8964BC4ADDED}"/>
          </ac:spMkLst>
        </pc:spChg>
        <pc:picChg chg="mod">
          <ac:chgData name="juyoung jung" userId="2cd33e9aba789339" providerId="LiveId" clId="{AA236221-2BE9-4F5F-A09F-FD46EB557B01}" dt="2026-01-14T00:51:17.507" v="313" actId="14826"/>
          <ac:picMkLst>
            <pc:docMk/>
            <pc:sldMk cId="1197021954" sldId="266"/>
            <ac:picMk id="8" creationId="{9008D76B-8AB4-5970-17E6-A95FB91E9AB5}"/>
          </ac:picMkLst>
        </pc:picChg>
      </pc:sldChg>
      <pc:sldChg chg="modSp add mod">
        <pc:chgData name="juyoung jung" userId="2cd33e9aba789339" providerId="LiveId" clId="{AA236221-2BE9-4F5F-A09F-FD46EB557B01}" dt="2026-01-14T00:54:54.926" v="378" actId="20577"/>
        <pc:sldMkLst>
          <pc:docMk/>
          <pc:sldMk cId="3823070294" sldId="267"/>
        </pc:sldMkLst>
        <pc:spChg chg="mod">
          <ac:chgData name="juyoung jung" userId="2cd33e9aba789339" providerId="LiveId" clId="{AA236221-2BE9-4F5F-A09F-FD46EB557B01}" dt="2026-01-14T00:54:54.926" v="378" actId="20577"/>
          <ac:spMkLst>
            <pc:docMk/>
            <pc:sldMk cId="3823070294" sldId="267"/>
            <ac:spMk id="5" creationId="{E81E795B-038B-8F87-5DA7-B47756F7520B}"/>
          </ac:spMkLst>
        </pc:spChg>
        <pc:picChg chg="mod">
          <ac:chgData name="juyoung jung" userId="2cd33e9aba789339" providerId="LiveId" clId="{AA236221-2BE9-4F5F-A09F-FD46EB557B01}" dt="2026-01-14T00:53:10.794" v="351" actId="14826"/>
          <ac:picMkLst>
            <pc:docMk/>
            <pc:sldMk cId="3823070294" sldId="267"/>
            <ac:picMk id="8" creationId="{473C80CF-D04B-D5C1-6994-85D5897364EC}"/>
          </ac:picMkLst>
        </pc:picChg>
      </pc:sldChg>
      <pc:sldChg chg="modSp add mod">
        <pc:chgData name="juyoung jung" userId="2cd33e9aba789339" providerId="LiveId" clId="{AA236221-2BE9-4F5F-A09F-FD46EB557B01}" dt="2026-01-14T00:55:01.148" v="379" actId="20577"/>
        <pc:sldMkLst>
          <pc:docMk/>
          <pc:sldMk cId="1869145835" sldId="268"/>
        </pc:sldMkLst>
        <pc:spChg chg="mod">
          <ac:chgData name="juyoung jung" userId="2cd33e9aba789339" providerId="LiveId" clId="{AA236221-2BE9-4F5F-A09F-FD46EB557B01}" dt="2026-01-14T00:55:01.148" v="379" actId="20577"/>
          <ac:spMkLst>
            <pc:docMk/>
            <pc:sldMk cId="1869145835" sldId="268"/>
            <ac:spMk id="5" creationId="{1ED7B29C-D68A-48B8-5D25-68EE33C2C251}"/>
          </ac:spMkLst>
        </pc:spChg>
        <pc:picChg chg="mod">
          <ac:chgData name="juyoung jung" userId="2cd33e9aba789339" providerId="LiveId" clId="{AA236221-2BE9-4F5F-A09F-FD46EB557B01}" dt="2026-01-14T00:53:25.763" v="357" actId="14826"/>
          <ac:picMkLst>
            <pc:docMk/>
            <pc:sldMk cId="1869145835" sldId="268"/>
            <ac:picMk id="8" creationId="{5F02BED0-7CE6-DED8-8210-3215DE513060}"/>
          </ac:picMkLst>
        </pc:picChg>
      </pc:sldChg>
      <pc:sldChg chg="modSp add mod">
        <pc:chgData name="juyoung jung" userId="2cd33e9aba789339" providerId="LiveId" clId="{AA236221-2BE9-4F5F-A09F-FD46EB557B01}" dt="2026-01-14T00:55:07.261" v="380" actId="20577"/>
        <pc:sldMkLst>
          <pc:docMk/>
          <pc:sldMk cId="3468853339" sldId="269"/>
        </pc:sldMkLst>
        <pc:spChg chg="mod">
          <ac:chgData name="juyoung jung" userId="2cd33e9aba789339" providerId="LiveId" clId="{AA236221-2BE9-4F5F-A09F-FD46EB557B01}" dt="2026-01-14T00:55:07.261" v="380" actId="20577"/>
          <ac:spMkLst>
            <pc:docMk/>
            <pc:sldMk cId="3468853339" sldId="269"/>
            <ac:spMk id="5" creationId="{160100F1-A8C0-3877-78D6-E3B9FDE9E77F}"/>
          </ac:spMkLst>
        </pc:spChg>
        <pc:picChg chg="mod">
          <ac:chgData name="juyoung jung" userId="2cd33e9aba789339" providerId="LiveId" clId="{AA236221-2BE9-4F5F-A09F-FD46EB557B01}" dt="2026-01-14T00:53:35.863" v="358" actId="14826"/>
          <ac:picMkLst>
            <pc:docMk/>
            <pc:sldMk cId="3468853339" sldId="269"/>
            <ac:picMk id="8" creationId="{6CF08D45-D0E9-C282-7046-3EF99290CC6E}"/>
          </ac:picMkLst>
        </pc:picChg>
      </pc:sldChg>
      <pc:sldChg chg="modSp add mod">
        <pc:chgData name="juyoung jung" userId="2cd33e9aba789339" providerId="LiveId" clId="{AA236221-2BE9-4F5F-A09F-FD46EB557B01}" dt="2026-01-14T00:55:10.948" v="381" actId="20577"/>
        <pc:sldMkLst>
          <pc:docMk/>
          <pc:sldMk cId="2576035909" sldId="270"/>
        </pc:sldMkLst>
        <pc:spChg chg="mod">
          <ac:chgData name="juyoung jung" userId="2cd33e9aba789339" providerId="LiveId" clId="{AA236221-2BE9-4F5F-A09F-FD46EB557B01}" dt="2026-01-14T00:55:10.948" v="381" actId="20577"/>
          <ac:spMkLst>
            <pc:docMk/>
            <pc:sldMk cId="2576035909" sldId="270"/>
            <ac:spMk id="5" creationId="{18CFDD62-B395-1658-EDCA-65F5F8937FC8}"/>
          </ac:spMkLst>
        </pc:spChg>
        <pc:picChg chg="mod">
          <ac:chgData name="juyoung jung" userId="2cd33e9aba789339" providerId="LiveId" clId="{AA236221-2BE9-4F5F-A09F-FD46EB557B01}" dt="2026-01-14T00:53:43.820" v="360" actId="14826"/>
          <ac:picMkLst>
            <pc:docMk/>
            <pc:sldMk cId="2576035909" sldId="270"/>
            <ac:picMk id="8" creationId="{03F8D1D4-B280-9505-C2AE-3CF4B708B5FF}"/>
          </ac:picMkLst>
        </pc:picChg>
      </pc:sldChg>
      <pc:sldChg chg="modSp add mod">
        <pc:chgData name="juyoung jung" userId="2cd33e9aba789339" providerId="LiveId" clId="{AA236221-2BE9-4F5F-A09F-FD46EB557B01}" dt="2026-01-14T00:55:14.842" v="382" actId="20577"/>
        <pc:sldMkLst>
          <pc:docMk/>
          <pc:sldMk cId="1189430210" sldId="271"/>
        </pc:sldMkLst>
        <pc:spChg chg="mod">
          <ac:chgData name="juyoung jung" userId="2cd33e9aba789339" providerId="LiveId" clId="{AA236221-2BE9-4F5F-A09F-FD46EB557B01}" dt="2026-01-14T00:55:14.842" v="382" actId="20577"/>
          <ac:spMkLst>
            <pc:docMk/>
            <pc:sldMk cId="1189430210" sldId="271"/>
            <ac:spMk id="5" creationId="{9B5628D1-8A31-2615-2F27-38F49CC8DD1E}"/>
          </ac:spMkLst>
        </pc:spChg>
        <pc:picChg chg="mod">
          <ac:chgData name="juyoung jung" userId="2cd33e9aba789339" providerId="LiveId" clId="{AA236221-2BE9-4F5F-A09F-FD46EB557B01}" dt="2026-01-14T00:54:17.784" v="377" actId="14826"/>
          <ac:picMkLst>
            <pc:docMk/>
            <pc:sldMk cId="1189430210" sldId="271"/>
            <ac:picMk id="8" creationId="{8998FD20-FCBA-5762-2C11-F16310119EE8}"/>
          </ac:picMkLst>
        </pc:pic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06FE3DB6-C877-9100-BD9B-F24AAD03CC9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부제목 2">
            <a:extLst>
              <a:ext uri="{FF2B5EF4-FFF2-40B4-BE49-F238E27FC236}">
                <a16:creationId xmlns:a16="http://schemas.microsoft.com/office/drawing/2014/main" id="{AF4199D6-ED10-0C33-DFCB-AD8FE2053D03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/>
              <a:t>클릭하여 마스터 부제목 스타일 편집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98623382-91CC-3891-FCF9-1F2B529468A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FD22EF-FA42-48AC-AD4A-25796D8A0622}" type="datetimeFigureOut">
              <a:rPr lang="ko-KR" altLang="en-US" smtClean="0"/>
              <a:t>2026-03-24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AF5A67A6-7D09-9DD4-BDD6-5923D87FB54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D4C0B60F-A5DA-0CD1-D6DC-6141DB531AD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E0CD1E-0D58-4C21-9152-0F86608D9B2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24836690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A12F6F60-4463-F0D1-495F-62B979C2229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>
            <a:extLst>
              <a:ext uri="{FF2B5EF4-FFF2-40B4-BE49-F238E27FC236}">
                <a16:creationId xmlns:a16="http://schemas.microsoft.com/office/drawing/2014/main" id="{8477DDE9-8F36-8C50-A8D9-2217623A904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97300D9F-8CC7-22EE-81AA-85445C5D696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FD22EF-FA42-48AC-AD4A-25796D8A0622}" type="datetimeFigureOut">
              <a:rPr lang="ko-KR" altLang="en-US" smtClean="0"/>
              <a:t>2026-03-24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ACD8D575-D388-9ABB-353D-5EE7457DD52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0AD39A8C-0E75-B48C-51D4-6BE3A1A74A1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E0CD1E-0D58-4C21-9152-0F86608D9B2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45452368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>
            <a:extLst>
              <a:ext uri="{FF2B5EF4-FFF2-40B4-BE49-F238E27FC236}">
                <a16:creationId xmlns:a16="http://schemas.microsoft.com/office/drawing/2014/main" id="{70376542-5735-4555-C72B-85B60E67A2F4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>
            <a:extLst>
              <a:ext uri="{FF2B5EF4-FFF2-40B4-BE49-F238E27FC236}">
                <a16:creationId xmlns:a16="http://schemas.microsoft.com/office/drawing/2014/main" id="{09473617-177C-6C11-0E26-665B7373A92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21013586-2FBB-E681-F609-F0ED4D378BB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FD22EF-FA42-48AC-AD4A-25796D8A0622}" type="datetimeFigureOut">
              <a:rPr lang="ko-KR" altLang="en-US" smtClean="0"/>
              <a:t>2026-03-24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B287F857-7E3F-4A82-4CC6-9CFBB9DE5B7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8A6F78B2-36A3-66E0-7AAD-6A1D476B178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E0CD1E-0D58-4C21-9152-0F86608D9B2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50079141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8CBDC274-8534-1B73-CC15-21EDD0C32C0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F8A505BF-5A78-6EAA-BB8C-6A08BE607DE1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8D72E146-12F5-25E2-6814-60DFF778C98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FD22EF-FA42-48AC-AD4A-25796D8A0622}" type="datetimeFigureOut">
              <a:rPr lang="ko-KR" altLang="en-US" smtClean="0"/>
              <a:t>2026-03-24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DA1FDE43-7192-CF5E-09B5-3B59405E181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15955A5B-EE22-1258-DFE9-EA1C233A2D1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E0CD1E-0D58-4C21-9152-0F86608D9B2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51268498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3E8408A1-EB4C-3F3E-65E1-C6764FE5733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4128D268-ED86-35EE-E1D3-F4868EA2C97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65B04E0F-B6DD-ABC0-433A-64FB9023CC1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FD22EF-FA42-48AC-AD4A-25796D8A0622}" type="datetimeFigureOut">
              <a:rPr lang="ko-KR" altLang="en-US" smtClean="0"/>
              <a:t>2026-03-24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6CE3DAFC-06E7-93F2-019D-63EDB5FEFCC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42679330-3C76-942C-6267-BBEC7CD9E81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E0CD1E-0D58-4C21-9152-0F86608D9B2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31962514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027A9699-FA34-530B-22D5-607EC02521E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2D039C9A-B290-42DB-57F9-441F854F6B26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내용 개체 틀 3">
            <a:extLst>
              <a:ext uri="{FF2B5EF4-FFF2-40B4-BE49-F238E27FC236}">
                <a16:creationId xmlns:a16="http://schemas.microsoft.com/office/drawing/2014/main" id="{3CD6BCC5-4C58-0219-EA1B-DB4F9FCCBCA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E71181D2-B457-5C7E-F65A-570B481AF44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FD22EF-FA42-48AC-AD4A-25796D8A0622}" type="datetimeFigureOut">
              <a:rPr lang="ko-KR" altLang="en-US" smtClean="0"/>
              <a:t>2026-03-24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536477D7-6BC3-CEA9-049C-A6B30CC5E9B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EC89F98A-BD32-21C9-13B3-90260D1E2AD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E0CD1E-0D58-4C21-9152-0F86608D9B2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51130047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DD9BB970-B75A-5EA4-B2B0-5F9E47D1F10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42874B73-A2A0-38EF-ED61-E28B3C2FBBD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내용 개체 틀 3">
            <a:extLst>
              <a:ext uri="{FF2B5EF4-FFF2-40B4-BE49-F238E27FC236}">
                <a16:creationId xmlns:a16="http://schemas.microsoft.com/office/drawing/2014/main" id="{D4394D12-B451-4D0F-1633-ACFEDCD710B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5" name="텍스트 개체 틀 4">
            <a:extLst>
              <a:ext uri="{FF2B5EF4-FFF2-40B4-BE49-F238E27FC236}">
                <a16:creationId xmlns:a16="http://schemas.microsoft.com/office/drawing/2014/main" id="{1928A3DC-C6DA-3629-8880-34C03780779D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6" name="내용 개체 틀 5">
            <a:extLst>
              <a:ext uri="{FF2B5EF4-FFF2-40B4-BE49-F238E27FC236}">
                <a16:creationId xmlns:a16="http://schemas.microsoft.com/office/drawing/2014/main" id="{9D656315-8264-3DAF-240A-3ACE6ED77274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7" name="날짜 개체 틀 6">
            <a:extLst>
              <a:ext uri="{FF2B5EF4-FFF2-40B4-BE49-F238E27FC236}">
                <a16:creationId xmlns:a16="http://schemas.microsoft.com/office/drawing/2014/main" id="{DACF447C-33D8-6754-DB6A-4C4BDE48A2A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FD22EF-FA42-48AC-AD4A-25796D8A0622}" type="datetimeFigureOut">
              <a:rPr lang="ko-KR" altLang="en-US" smtClean="0"/>
              <a:t>2026-03-24</a:t>
            </a:fld>
            <a:endParaRPr lang="ko-KR" altLang="en-US"/>
          </a:p>
        </p:txBody>
      </p:sp>
      <p:sp>
        <p:nvSpPr>
          <p:cNvPr id="8" name="바닥글 개체 틀 7">
            <a:extLst>
              <a:ext uri="{FF2B5EF4-FFF2-40B4-BE49-F238E27FC236}">
                <a16:creationId xmlns:a16="http://schemas.microsoft.com/office/drawing/2014/main" id="{1281A189-F764-4B64-74DD-692B66613DB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>
            <a:extLst>
              <a:ext uri="{FF2B5EF4-FFF2-40B4-BE49-F238E27FC236}">
                <a16:creationId xmlns:a16="http://schemas.microsoft.com/office/drawing/2014/main" id="{D89982F4-FA93-381F-246E-F847BCA64BC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E0CD1E-0D58-4C21-9152-0F86608D9B2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64403521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712666A4-42B1-9F1D-5745-491A7B86CE9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날짜 개체 틀 2">
            <a:extLst>
              <a:ext uri="{FF2B5EF4-FFF2-40B4-BE49-F238E27FC236}">
                <a16:creationId xmlns:a16="http://schemas.microsoft.com/office/drawing/2014/main" id="{AC658E42-B160-4F0E-5E67-AD76AC6A594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FD22EF-FA42-48AC-AD4A-25796D8A0622}" type="datetimeFigureOut">
              <a:rPr lang="ko-KR" altLang="en-US" smtClean="0"/>
              <a:t>2026-03-24</a:t>
            </a:fld>
            <a:endParaRPr lang="ko-KR" altLang="en-US"/>
          </a:p>
        </p:txBody>
      </p:sp>
      <p:sp>
        <p:nvSpPr>
          <p:cNvPr id="4" name="바닥글 개체 틀 3">
            <a:extLst>
              <a:ext uri="{FF2B5EF4-FFF2-40B4-BE49-F238E27FC236}">
                <a16:creationId xmlns:a16="http://schemas.microsoft.com/office/drawing/2014/main" id="{A138FF40-14C1-88D4-27F0-A63C0DA151A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>
            <a:extLst>
              <a:ext uri="{FF2B5EF4-FFF2-40B4-BE49-F238E27FC236}">
                <a16:creationId xmlns:a16="http://schemas.microsoft.com/office/drawing/2014/main" id="{BEA5E01F-1C4F-3862-D40D-841942DBD56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E0CD1E-0D58-4C21-9152-0F86608D9B2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19094343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>
            <a:extLst>
              <a:ext uri="{FF2B5EF4-FFF2-40B4-BE49-F238E27FC236}">
                <a16:creationId xmlns:a16="http://schemas.microsoft.com/office/drawing/2014/main" id="{6F30E4A1-5E6E-C95C-104F-FC4B31EF70E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FD22EF-FA42-48AC-AD4A-25796D8A0622}" type="datetimeFigureOut">
              <a:rPr lang="ko-KR" altLang="en-US" smtClean="0"/>
              <a:t>2026-03-24</a:t>
            </a:fld>
            <a:endParaRPr lang="ko-KR" altLang="en-US"/>
          </a:p>
        </p:txBody>
      </p:sp>
      <p:sp>
        <p:nvSpPr>
          <p:cNvPr id="3" name="바닥글 개체 틀 2">
            <a:extLst>
              <a:ext uri="{FF2B5EF4-FFF2-40B4-BE49-F238E27FC236}">
                <a16:creationId xmlns:a16="http://schemas.microsoft.com/office/drawing/2014/main" id="{1746CA0E-6895-19B7-D618-64E37439AD8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>
            <a:extLst>
              <a:ext uri="{FF2B5EF4-FFF2-40B4-BE49-F238E27FC236}">
                <a16:creationId xmlns:a16="http://schemas.microsoft.com/office/drawing/2014/main" id="{1B50876F-09AE-8983-8066-78459A6C2FE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E0CD1E-0D58-4C21-9152-0F86608D9B2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4205828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FCEE69FD-EADC-C723-CE50-77F8D037E5A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D6251D6D-405B-F30E-F797-E9B65B5B5DCB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텍스트 개체 틀 3">
            <a:extLst>
              <a:ext uri="{FF2B5EF4-FFF2-40B4-BE49-F238E27FC236}">
                <a16:creationId xmlns:a16="http://schemas.microsoft.com/office/drawing/2014/main" id="{4FC24759-C098-6F26-ED82-39464889306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EACDE452-4D26-B2CC-3F99-EECDE977799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FD22EF-FA42-48AC-AD4A-25796D8A0622}" type="datetimeFigureOut">
              <a:rPr lang="ko-KR" altLang="en-US" smtClean="0"/>
              <a:t>2026-03-24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0F07BF85-6CE8-C0BD-64BD-D59B9C825CF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D7EFD54D-D92B-B591-3DD3-785DA53AE5E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E0CD1E-0D58-4C21-9152-0F86608D9B2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02020374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C6FB1FB0-1830-B857-4777-579B9EB06CC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그림 개체 틀 2">
            <a:extLst>
              <a:ext uri="{FF2B5EF4-FFF2-40B4-BE49-F238E27FC236}">
                <a16:creationId xmlns:a16="http://schemas.microsoft.com/office/drawing/2014/main" id="{00BE462B-A5D7-EA52-A8C9-52A28A3636FC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>
            <a:extLst>
              <a:ext uri="{FF2B5EF4-FFF2-40B4-BE49-F238E27FC236}">
                <a16:creationId xmlns:a16="http://schemas.microsoft.com/office/drawing/2014/main" id="{E6596CBC-E044-5E7E-43CC-144D13D974A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8FE278A3-F94E-C0C0-CF3A-98F32C80AF2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FD22EF-FA42-48AC-AD4A-25796D8A0622}" type="datetimeFigureOut">
              <a:rPr lang="ko-KR" altLang="en-US" smtClean="0"/>
              <a:t>2026-03-24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E9EBE180-0C9A-034E-BD1D-1AD6865B57C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BDDFB1E6-CB54-01A6-EC97-4D9BECAB6B6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E0CD1E-0D58-4C21-9152-0F86608D9B2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42702055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>
            <a:extLst>
              <a:ext uri="{FF2B5EF4-FFF2-40B4-BE49-F238E27FC236}">
                <a16:creationId xmlns:a16="http://schemas.microsoft.com/office/drawing/2014/main" id="{FEA06F52-4A01-0CE9-11B6-9BF8B0FC74C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F404AAA5-C9B8-8B53-CEDE-3679CA9C699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81EF9B1F-5C5B-8071-3347-A5F3E9E5F3F4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DFD22EF-FA42-48AC-AD4A-25796D8A0622}" type="datetimeFigureOut">
              <a:rPr lang="ko-KR" altLang="en-US" smtClean="0"/>
              <a:t>2026-03-24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472B9CC2-B973-0ADD-FEAD-2B357A6282DA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FF77252D-A75F-E698-CF97-85344F784778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BE0CD1E-0D58-4C21-9152-0F86608D9B2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44947763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7374965" y="3224758"/>
            <a:ext cx="4475659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Material 1. (a) Kaplan-Meier curve for hypertension free survival probability in SII quartile (All participants) </a:t>
            </a:r>
            <a:endParaRPr lang="ko-KR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직사각형 5"/>
          <p:cNvSpPr/>
          <p:nvPr/>
        </p:nvSpPr>
        <p:spPr>
          <a:xfrm>
            <a:off x="184834" y="568190"/>
            <a:ext cx="52770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dirty="0"/>
              <a:t>(a) </a:t>
            </a:r>
            <a:endParaRPr lang="ko-KR" altLang="en-US" dirty="0"/>
          </a:p>
        </p:txBody>
      </p:sp>
      <p:pic>
        <p:nvPicPr>
          <p:cNvPr id="8" name="내용 개체 틀 7" descr="텍스트, 스크린샷, 도표, 그래프이(가) 표시된 사진&#10;&#10;AI 생성 콘텐츠는 정확하지 않을 수 있습니다.">
            <a:extLst>
              <a:ext uri="{FF2B5EF4-FFF2-40B4-BE49-F238E27FC236}">
                <a16:creationId xmlns:a16="http://schemas.microsoft.com/office/drawing/2014/main" id="{3768716D-B2F1-0E9C-21DA-C561F1802626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39976" y="63197"/>
            <a:ext cx="5921012" cy="6784197"/>
          </a:xfrm>
        </p:spPr>
      </p:pic>
    </p:spTree>
    <p:extLst>
      <p:ext uri="{BB962C8B-B14F-4D97-AF65-F5344CB8AC3E}">
        <p14:creationId xmlns:p14="http://schemas.microsoft.com/office/powerpoint/2010/main" val="358628706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351D8F04-CB0C-2D3D-7215-314DA6517A45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DD6B9412-378D-BA20-9915-1F7FDB2B396D}"/>
              </a:ext>
            </a:extLst>
          </p:cNvPr>
          <p:cNvSpPr txBox="1"/>
          <p:nvPr/>
        </p:nvSpPr>
        <p:spPr>
          <a:xfrm>
            <a:off x="7374965" y="3224758"/>
            <a:ext cx="4301923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</a:t>
            </a:r>
            <a:r>
              <a:rPr kumimoji="0" lang="en-US" altLang="ko-KR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Material</a:t>
            </a:r>
            <a:r>
              <a:rPr lang="en-US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 1. (b) Kaplan-Meier curve for hypertension free survival probability in SIRI quartile (All participants)</a:t>
            </a:r>
            <a:r>
              <a:rPr lang="en-US" altLang="ko-KR" dirty="0"/>
              <a:t> </a:t>
            </a:r>
            <a:endParaRPr lang="ko-KR" altLang="en-US" dirty="0"/>
          </a:p>
        </p:txBody>
      </p:sp>
      <p:sp>
        <p:nvSpPr>
          <p:cNvPr id="6" name="직사각형 5">
            <a:extLst>
              <a:ext uri="{FF2B5EF4-FFF2-40B4-BE49-F238E27FC236}">
                <a16:creationId xmlns:a16="http://schemas.microsoft.com/office/drawing/2014/main" id="{5960B0CE-E762-07DA-FB0D-45AE865F6E01}"/>
              </a:ext>
            </a:extLst>
          </p:cNvPr>
          <p:cNvSpPr/>
          <p:nvPr/>
        </p:nvSpPr>
        <p:spPr>
          <a:xfrm>
            <a:off x="184834" y="568190"/>
            <a:ext cx="545342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dirty="0"/>
              <a:t>(b) </a:t>
            </a:r>
            <a:endParaRPr lang="ko-KR" altLang="en-US" dirty="0"/>
          </a:p>
        </p:txBody>
      </p:sp>
      <p:pic>
        <p:nvPicPr>
          <p:cNvPr id="8" name="내용 개체 틀 7">
            <a:extLst>
              <a:ext uri="{FF2B5EF4-FFF2-40B4-BE49-F238E27FC236}">
                <a16:creationId xmlns:a16="http://schemas.microsoft.com/office/drawing/2014/main" id="{3541C844-66CB-C576-1C2F-0BE227F8B28D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939976" y="63197"/>
            <a:ext cx="5921012" cy="6784197"/>
          </a:xfrm>
        </p:spPr>
      </p:pic>
    </p:spTree>
    <p:extLst>
      <p:ext uri="{BB962C8B-B14F-4D97-AF65-F5344CB8AC3E}">
        <p14:creationId xmlns:p14="http://schemas.microsoft.com/office/powerpoint/2010/main" val="376174843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819F3AE8-118A-0F1A-0CBD-88142D003C4C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3780BE0B-03D2-241F-91E8-4B15C600944C}"/>
              </a:ext>
            </a:extLst>
          </p:cNvPr>
          <p:cNvSpPr txBox="1"/>
          <p:nvPr/>
        </p:nvSpPr>
        <p:spPr>
          <a:xfrm>
            <a:off x="7374965" y="3224759"/>
            <a:ext cx="4320212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</a:t>
            </a:r>
            <a:r>
              <a:rPr kumimoji="0" lang="en-US" altLang="ko-KR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Material 1</a:t>
            </a:r>
            <a:r>
              <a:rPr lang="en-US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(c) Kaplan-Meier curve for hypertension free survival probability in NLR quartile (All participants) </a:t>
            </a:r>
            <a:endParaRPr lang="ko-KR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직사각형 5">
            <a:extLst>
              <a:ext uri="{FF2B5EF4-FFF2-40B4-BE49-F238E27FC236}">
                <a16:creationId xmlns:a16="http://schemas.microsoft.com/office/drawing/2014/main" id="{A6EDB326-B2E4-CDDC-F286-1F28F13410A6}"/>
              </a:ext>
            </a:extLst>
          </p:cNvPr>
          <p:cNvSpPr/>
          <p:nvPr/>
        </p:nvSpPr>
        <p:spPr>
          <a:xfrm>
            <a:off x="184834" y="568190"/>
            <a:ext cx="51648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dirty="0"/>
              <a:t>(c) </a:t>
            </a:r>
            <a:endParaRPr lang="ko-KR" altLang="en-US" dirty="0"/>
          </a:p>
        </p:txBody>
      </p:sp>
      <p:pic>
        <p:nvPicPr>
          <p:cNvPr id="8" name="내용 개체 틀 7" descr="텍스트, 스크린샷, 도표, 그래프이(가) 표시된 사진&#10;&#10;AI 생성 콘텐츠는 정확하지 않을 수 있습니다.">
            <a:extLst>
              <a:ext uri="{FF2B5EF4-FFF2-40B4-BE49-F238E27FC236}">
                <a16:creationId xmlns:a16="http://schemas.microsoft.com/office/drawing/2014/main" id="{A7FFC623-479A-168F-6D1A-C758279F569D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39976" y="63197"/>
            <a:ext cx="5921012" cy="6784197"/>
          </a:xfrm>
        </p:spPr>
      </p:pic>
    </p:spTree>
    <p:extLst>
      <p:ext uri="{BB962C8B-B14F-4D97-AF65-F5344CB8AC3E}">
        <p14:creationId xmlns:p14="http://schemas.microsoft.com/office/powerpoint/2010/main" val="293183660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FBE57559-9A79-365E-0157-B8F0DA81392F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C8210C0E-6DD6-F569-8F14-E0CEDAFB67CC}"/>
              </a:ext>
            </a:extLst>
          </p:cNvPr>
          <p:cNvSpPr txBox="1"/>
          <p:nvPr/>
        </p:nvSpPr>
        <p:spPr>
          <a:xfrm>
            <a:off x="7374965" y="3224759"/>
            <a:ext cx="4320212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Material 1. (d) Kaplan-Meier curve for hypertension free survival probability in MLR quartile (All participants) </a:t>
            </a:r>
            <a:endParaRPr lang="ko-KR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직사각형 5">
            <a:extLst>
              <a:ext uri="{FF2B5EF4-FFF2-40B4-BE49-F238E27FC236}">
                <a16:creationId xmlns:a16="http://schemas.microsoft.com/office/drawing/2014/main" id="{FDB595E4-DC5B-D2DA-8FBE-31ABC283ECD7}"/>
              </a:ext>
            </a:extLst>
          </p:cNvPr>
          <p:cNvSpPr/>
          <p:nvPr/>
        </p:nvSpPr>
        <p:spPr>
          <a:xfrm>
            <a:off x="184834" y="568190"/>
            <a:ext cx="546945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dirty="0"/>
              <a:t>(d) </a:t>
            </a:r>
            <a:endParaRPr lang="ko-KR" altLang="en-US" dirty="0"/>
          </a:p>
        </p:txBody>
      </p:sp>
      <p:pic>
        <p:nvPicPr>
          <p:cNvPr id="8" name="내용 개체 틀 7" descr="텍스트, 스크린샷, 도표, 그래프이(가) 표시된 사진&#10;&#10;AI 생성 콘텐츠는 정확하지 않을 수 있습니다.">
            <a:extLst>
              <a:ext uri="{FF2B5EF4-FFF2-40B4-BE49-F238E27FC236}">
                <a16:creationId xmlns:a16="http://schemas.microsoft.com/office/drawing/2014/main" id="{3DA56844-C749-15FD-C9B3-5D2A753FE069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39976" y="63197"/>
            <a:ext cx="5921012" cy="6784197"/>
          </a:xfrm>
        </p:spPr>
      </p:pic>
    </p:spTree>
    <p:extLst>
      <p:ext uri="{BB962C8B-B14F-4D97-AF65-F5344CB8AC3E}">
        <p14:creationId xmlns:p14="http://schemas.microsoft.com/office/powerpoint/2010/main" val="384563706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D7F7197A-81A6-5D96-E838-09677AD48CFF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C4A3BC84-AAE2-7D27-B1B4-C1255EF3949E}"/>
              </a:ext>
            </a:extLst>
          </p:cNvPr>
          <p:cNvSpPr txBox="1"/>
          <p:nvPr/>
        </p:nvSpPr>
        <p:spPr>
          <a:xfrm>
            <a:off x="7374965" y="3224759"/>
            <a:ext cx="4311068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Material 1. (e) Kaplan-Meier curve for hypertension free survival probability in PLR quartile (All participants) </a:t>
            </a:r>
            <a:endParaRPr lang="ko-KR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직사각형 5">
            <a:extLst>
              <a:ext uri="{FF2B5EF4-FFF2-40B4-BE49-F238E27FC236}">
                <a16:creationId xmlns:a16="http://schemas.microsoft.com/office/drawing/2014/main" id="{6A94608A-596A-A969-54C4-8C7BF4423D5F}"/>
              </a:ext>
            </a:extLst>
          </p:cNvPr>
          <p:cNvSpPr/>
          <p:nvPr/>
        </p:nvSpPr>
        <p:spPr>
          <a:xfrm>
            <a:off x="184834" y="568190"/>
            <a:ext cx="530915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dirty="0"/>
              <a:t>(e) </a:t>
            </a:r>
            <a:endParaRPr lang="ko-KR" altLang="en-US" dirty="0"/>
          </a:p>
        </p:txBody>
      </p:sp>
      <p:pic>
        <p:nvPicPr>
          <p:cNvPr id="8" name="내용 개체 틀 7">
            <a:extLst>
              <a:ext uri="{FF2B5EF4-FFF2-40B4-BE49-F238E27FC236}">
                <a16:creationId xmlns:a16="http://schemas.microsoft.com/office/drawing/2014/main" id="{0BCA3891-1896-F941-4B62-9A677661E6F0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939976" y="63197"/>
            <a:ext cx="5921012" cy="6784197"/>
          </a:xfrm>
        </p:spPr>
      </p:pic>
    </p:spTree>
    <p:extLst>
      <p:ext uri="{BB962C8B-B14F-4D97-AF65-F5344CB8AC3E}">
        <p14:creationId xmlns:p14="http://schemas.microsoft.com/office/powerpoint/2010/main" val="329290075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03</TotalTime>
  <Words>120</Words>
  <Application>Microsoft Office PowerPoint</Application>
  <PresentationFormat>와이드스크린</PresentationFormat>
  <Paragraphs>10</Paragraphs>
  <Slides>5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3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5</vt:i4>
      </vt:variant>
    </vt:vector>
  </HeadingPairs>
  <TitlesOfParts>
    <vt:vector size="9" baseType="lpstr">
      <vt:lpstr>맑은 고딕</vt:lpstr>
      <vt:lpstr>Arial</vt:lpstr>
      <vt:lpstr>Times New Roman</vt:lpstr>
      <vt:lpstr>Office 테마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juyoung jung</dc:creator>
  <cp:lastModifiedBy>이제인</cp:lastModifiedBy>
  <cp:revision>9</cp:revision>
  <dcterms:created xsi:type="dcterms:W3CDTF">2023-10-04T07:58:26Z</dcterms:created>
  <dcterms:modified xsi:type="dcterms:W3CDTF">2026-03-24T05:17:31Z</dcterms:modified>
</cp:coreProperties>
</file>